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288588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header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dt" idx="1"/>
          </p:nvPr>
        </p:nvSpPr>
        <p:spPr>
          <a:xfrm>
            <a:off x="414504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3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sldImg"/>
          </p:nvPr>
        </p:nvSpPr>
        <p:spPr>
          <a:xfrm>
            <a:off x="957240" y="720360"/>
            <a:ext cx="5400720" cy="3600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800" spc="-1" strike="noStrike">
                <a:solidFill>
                  <a:srgbClr val="ffff00"/>
                </a:solidFill>
                <a:latin typeface="Times New Roman"/>
              </a:rPr>
              <a:t>Click to move the slide</a:t>
            </a: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 type="body"/>
          </p:nvPr>
        </p:nvSpPr>
        <p:spPr>
          <a:xfrm>
            <a:off x="974880" y="4560480"/>
            <a:ext cx="5365440" cy="431964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5"/>
          <p:cNvSpPr>
            <a:spLocks noGrp="1"/>
          </p:cNvSpPr>
          <p:nvPr>
            <p:ph type="ftr" idx="2"/>
          </p:nvPr>
        </p:nvSpPr>
        <p:spPr>
          <a:xfrm>
            <a:off x="0" y="912168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lstStyle>
            <a:lvl1pPr indent="0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3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6"/>
          <p:cNvSpPr>
            <a:spLocks noGrp="1"/>
          </p:cNvSpPr>
          <p:nvPr>
            <p:ph type="sldNum" idx="3"/>
          </p:nvPr>
        </p:nvSpPr>
        <p:spPr>
          <a:xfrm>
            <a:off x="4145040" y="912168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3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C2B4339A-2809-45D8-9233-B5B08ACB3EC8}" type="slidenum"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 txBox="1"/>
          <p:nvPr/>
        </p:nvSpPr>
        <p:spPr>
          <a:xfrm>
            <a:off x="4145040" y="912168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496E77FD-FB23-4212-A363-2522C799D062}" type="slidenum"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 txBox="1"/>
          <p:nvPr/>
        </p:nvSpPr>
        <p:spPr>
          <a:xfrm>
            <a:off x="0" y="912168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 txBox="1"/>
          <p:nvPr/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header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 txBox="1"/>
          <p:nvPr/>
        </p:nvSpPr>
        <p:spPr>
          <a:xfrm>
            <a:off x="414504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957240" y="720720"/>
            <a:ext cx="5400720" cy="360036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ethod of choice is CE but with the large number of samples we couldn’t afford to pay or buy the machine. Marco’s lab boo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77281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1125000" y="3826080"/>
            <a:ext cx="77281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85000" y="167652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1125000" y="382608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5085000" y="382608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24883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738240" y="1676520"/>
            <a:ext cx="24883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351120" y="1676520"/>
            <a:ext cx="24883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1125000" y="3826080"/>
            <a:ext cx="24883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738240" y="3826080"/>
            <a:ext cx="24883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351120" y="3826080"/>
            <a:ext cx="24883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1125000" y="1676520"/>
            <a:ext cx="772812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7728120" cy="41148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3771000" cy="41148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5085000" y="1676520"/>
            <a:ext cx="3771000" cy="41148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39560" y="266400"/>
            <a:ext cx="7772400" cy="5122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5085000" y="1676520"/>
            <a:ext cx="3771000" cy="41148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1125000" y="382608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3771000" cy="41148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5085000" y="167652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5085000" y="382608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1125000" y="167652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5085000" y="1676520"/>
            <a:ext cx="377100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1125000" y="3826080"/>
            <a:ext cx="7728120" cy="19627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279f"/>
            </a:gs>
            <a:gs pos="100000">
              <a:srgbClr val="00175f"/>
            </a:gs>
          </a:gsLst>
          <a:path path="rect">
            <a:fillToRect l="50000" t="50000" r="50000" b="50000"/>
          </a:path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39560" y="266400"/>
            <a:ext cx="7772400" cy="11048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800" spc="-1" strike="noStrike">
                <a:solidFill>
                  <a:srgbClr val="ffff00"/>
                </a:solidFill>
                <a:latin typeface="Times New Roman"/>
              </a:rPr>
              <a:t>Click to edit the title text format</a:t>
            </a:r>
            <a:endParaRPr b="1" lang="en-US" sz="48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125000" y="1676520"/>
            <a:ext cx="7728120" cy="41148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 fontScale="88000"/>
          </a:bodyPr>
          <a:p>
            <a:pPr marL="301680" indent="-301680">
              <a:spcBef>
                <a:spcPts val="901"/>
              </a:spcBef>
              <a:buClr>
                <a:srgbClr val="ff0000"/>
              </a:buClr>
              <a:buSzPct val="75000"/>
              <a:buFont typeface="Monotype Sorts" charset="2"/>
              <a:buChar char="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Times New Roman"/>
              </a:rPr>
              <a:t>Click to edit the outline text format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  <a:p>
            <a:pPr lvl="1" marL="653760" indent="-251280">
              <a:spcBef>
                <a:spcPts val="901"/>
              </a:spcBef>
              <a:buClr>
                <a:srgbClr val="ffffff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Times New Roman"/>
              </a:rPr>
              <a:t>Second Outline Level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  <a:p>
            <a:pPr lvl="2" marL="1005840" indent="-200880">
              <a:spcBef>
                <a:spcPts val="901"/>
              </a:spcBef>
              <a:buClr>
                <a:srgbClr val="ffffff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Times New Roman"/>
              </a:rPr>
              <a:t>Third Outline Level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  <a:p>
            <a:pPr lvl="3" marL="1407960" indent="-200880">
              <a:spcBef>
                <a:spcPts val="901"/>
              </a:spcBef>
              <a:buClr>
                <a:srgbClr val="ff00ff"/>
              </a:buClr>
              <a:buSzPct val="65000"/>
              <a:buFont typeface="Monotype Sorts" charset="2"/>
              <a:buChar char="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Times New Roman"/>
              </a:rPr>
              <a:t>Fourth Outline Level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  <a:p>
            <a:pPr lvl="4" marL="1810440" indent="-200880">
              <a:spcBef>
                <a:spcPts val="901"/>
              </a:spcBef>
              <a:buClr>
                <a:srgbClr val="ffffff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Times New Roman"/>
              </a:rPr>
              <a:t>Fifth Outline Level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  <a:p>
            <a:pPr lvl="5" marL="1810440" indent="-200880">
              <a:spcBef>
                <a:spcPts val="901"/>
              </a:spcBef>
              <a:buClr>
                <a:srgbClr val="ffffff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Times New Roman"/>
              </a:rPr>
              <a:t>Sixth Outline Level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  <a:p>
            <a:pPr lvl="6" marL="1810440" indent="-200880">
              <a:spcBef>
                <a:spcPts val="901"/>
              </a:spcBef>
              <a:buClr>
                <a:srgbClr val="ffffff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Times New Roman"/>
              </a:rPr>
              <a:t>Seventh Outline Level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2723" t="16835" r="25623" b="35930"/>
          <a:stretch/>
        </p:blipFill>
        <p:spPr>
          <a:xfrm>
            <a:off x="985680" y="2362320"/>
            <a:ext cx="8315640" cy="35812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 flipV="1">
            <a:off x="4638600" y="5638680"/>
            <a:ext cx="0" cy="511200"/>
          </a:xfrm>
          <a:prstGeom prst="line">
            <a:avLst/>
          </a:prstGeom>
          <a:ln w="38160">
            <a:solidFill>
              <a:srgbClr val="ff0000"/>
            </a:solidFill>
            <a:miter/>
            <a:tailEnd len="lg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4110480" y="6095880"/>
            <a:ext cx="10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45 CAG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482120" y="1935000"/>
            <a:ext cx="73450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POSITIVE CONTROL from HD patient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flipV="1">
            <a:off x="3497400" y="5638680"/>
            <a:ext cx="0" cy="511200"/>
          </a:xfrm>
          <a:prstGeom prst="line">
            <a:avLst/>
          </a:prstGeom>
          <a:ln w="38160">
            <a:solidFill>
              <a:srgbClr val="ff0000"/>
            </a:solidFill>
            <a:miter/>
            <a:tailEnd len="lg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2993040" y="6095880"/>
            <a:ext cx="10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7 CAG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723960" y="1676520"/>
            <a:ext cx="8991720" cy="4800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355760" y="2590920"/>
            <a:ext cx="380880" cy="30456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202040" y="2514600"/>
            <a:ext cx="142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. Agarose gel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257480" y="4038480"/>
            <a:ext cx="380880" cy="30492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098720" y="3962520"/>
            <a:ext cx="2541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. Capillary electrophoresis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723960" y="1066680"/>
            <a:ext cx="7620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Mackenzie BMC Neurology Supplemental Figure 1.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07-13T22:45:37Z</dcterms:created>
  <dc:creator>LIS WS24</dc:creator>
  <dc:description/>
  <dc:language>en-US</dc:language>
  <cp:lastModifiedBy>Blair R. Leavitt</cp:lastModifiedBy>
  <cp:lastPrinted>2000-10-12T17:19:47Z</cp:lastPrinted>
  <dcterms:modified xsi:type="dcterms:W3CDTF">2006-06-26T06:42:26Z</dcterms:modified>
  <cp:revision>185</cp:revision>
  <dc:subject/>
  <dc:title>No Slide Title</dc:title>
</cp:coreProperties>
</file>